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C2289-9566-44F4-AF88-58D95282E441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1DAAE-2B5F-4E89-AC20-83D92FF1AA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2353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C2289-9566-44F4-AF88-58D95282E441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1DAAE-2B5F-4E89-AC20-83D92FF1AA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85851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C2289-9566-44F4-AF88-58D95282E441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1DAAE-2B5F-4E89-AC20-83D92FF1AA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9475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C2289-9566-44F4-AF88-58D95282E441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1DAAE-2B5F-4E89-AC20-83D92FF1AA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03614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C2289-9566-44F4-AF88-58D95282E441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1DAAE-2B5F-4E89-AC20-83D92FF1AA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11479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C2289-9566-44F4-AF88-58D95282E441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1DAAE-2B5F-4E89-AC20-83D92FF1AA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37622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C2289-9566-44F4-AF88-58D95282E441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1DAAE-2B5F-4E89-AC20-83D92FF1AA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86415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C2289-9566-44F4-AF88-58D95282E441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1DAAE-2B5F-4E89-AC20-83D92FF1AA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97845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C2289-9566-44F4-AF88-58D95282E441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1DAAE-2B5F-4E89-AC20-83D92FF1AA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3980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C2289-9566-44F4-AF88-58D95282E441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1DAAE-2B5F-4E89-AC20-83D92FF1AA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46909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C2289-9566-44F4-AF88-58D95282E441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1DAAE-2B5F-4E89-AC20-83D92FF1AA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3001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CC2289-9566-44F4-AF88-58D95282E441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A1DAAE-2B5F-4E89-AC20-83D92FF1AA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4075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FigS3_finalplots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207818"/>
            <a:ext cx="9144000" cy="665018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728831" y="27817"/>
            <a:ext cx="1185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Figure S3</a:t>
            </a:r>
            <a:endParaRPr lang="en-US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5820859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701421" y="150126"/>
            <a:ext cx="8693624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Figure S3. </a:t>
            </a:r>
            <a:r>
              <a:rPr lang="en-US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Example </a:t>
            </a:r>
            <a:r>
              <a:rPr lang="en-US" dirty="0" err="1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preCC</a:t>
            </a:r>
            <a:r>
              <a:rPr lang="en-US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baseline and final Penh data demonstrating a range of responses to sensitization and challenge with house dust mite allergen. Note that in some cases, e.g., Fig. S3R (OR5401m137 at 6.25 mg/ml methacholine), Penh after sensitization and challenge with house dust mite allergen is lower than at baseline, as was observed in two founder strains (C57BL/6J and PWK/</a:t>
            </a:r>
            <a:r>
              <a:rPr lang="en-US" dirty="0" err="1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PhJ</a:t>
            </a:r>
            <a:r>
              <a:rPr lang="en-US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19277009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3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MS Mincho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Wolper</dc:creator>
  <cp:lastModifiedBy>Sarah Wolper</cp:lastModifiedBy>
  <cp:revision>1</cp:revision>
  <dcterms:created xsi:type="dcterms:W3CDTF">2016-07-20T19:34:50Z</dcterms:created>
  <dcterms:modified xsi:type="dcterms:W3CDTF">2016-07-20T19:34:58Z</dcterms:modified>
</cp:coreProperties>
</file>